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6" userDrawn="1">
          <p15:clr>
            <a:srgbClr val="A4A3A4"/>
          </p15:clr>
        </p15:guide>
        <p15:guide id="2" pos="51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6F699F"/>
    <a:srgbClr val="524D79"/>
    <a:srgbClr val="6EB38F"/>
    <a:srgbClr val="4B8E6B"/>
    <a:srgbClr val="455F51"/>
    <a:srgbClr val="70898F"/>
    <a:srgbClr val="4472C4"/>
    <a:srgbClr val="39B882"/>
    <a:srgbClr val="354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73B150-AAE0-44EB-8A0C-CD63B0B2E335}" v="36" dt="2022-09-14T08:58:55.0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694"/>
  </p:normalViewPr>
  <p:slideViewPr>
    <p:cSldViewPr snapToGrid="0" snapToObjects="1">
      <p:cViewPr varScale="1">
        <p:scale>
          <a:sx n="68" d="100"/>
          <a:sy n="68" d="100"/>
        </p:scale>
        <p:origin x="1212" y="60"/>
      </p:cViewPr>
      <p:guideLst>
        <p:guide orient="horz" pos="1366"/>
        <p:guide pos="513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0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77858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TheTxIDJournal  @KottonNelson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74288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632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Kotton CN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</a:t>
            </a:r>
            <a:r>
              <a:rPr lang="en-US" sz="1200" b="1" i="1">
                <a:solidFill>
                  <a:schemeClr val="bg1"/>
                </a:solidFill>
              </a:rPr>
              <a:t>Infectious Disease</a:t>
            </a:r>
            <a:r>
              <a:rPr lang="en-US" sz="1200">
                <a:solidFill>
                  <a:schemeClr val="bg1"/>
                </a:solidFill>
              </a:rPr>
              <a:t>.  </a:t>
            </a:r>
            <a:r>
              <a:rPr lang="en-US" sz="1200" dirty="0">
                <a:solidFill>
                  <a:schemeClr val="bg1"/>
                </a:solidFill>
              </a:rPr>
              <a:t>2022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-64649"/>
            <a:ext cx="119234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bg1"/>
                </a:solidFill>
              </a:rPr>
              <a:t>Cytomegalovirus in the transplant setting: where are we now and what happens next? </a:t>
            </a:r>
            <a:br>
              <a:rPr lang="en-GB" sz="2000" b="1" dirty="0">
                <a:solidFill>
                  <a:schemeClr val="bg1"/>
                </a:solidFill>
              </a:rPr>
            </a:br>
            <a:r>
              <a:rPr lang="en-GB" sz="2000" b="1" dirty="0">
                <a:solidFill>
                  <a:schemeClr val="bg1"/>
                </a:solidFill>
              </a:rPr>
              <a:t>A report from the International CMV Symposium 2021</a:t>
            </a:r>
            <a:endParaRPr lang="en-US" sz="2000" b="1" dirty="0">
              <a:solidFill>
                <a:schemeClr val="bg1"/>
              </a:solidFill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195C5925-B75B-EFBF-E167-861AC5C78441}"/>
              </a:ext>
            </a:extLst>
          </p:cNvPr>
          <p:cNvGrpSpPr/>
          <p:nvPr/>
        </p:nvGrpSpPr>
        <p:grpSpPr>
          <a:xfrm>
            <a:off x="157317" y="1561383"/>
            <a:ext cx="3846226" cy="3846226"/>
            <a:chOff x="157317" y="1343666"/>
            <a:chExt cx="3846226" cy="3846226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CECA940-8BEB-300B-5802-3FCD055AA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7317" y="1343666"/>
              <a:ext cx="3846226" cy="3846226"/>
            </a:xfrm>
            <a:prstGeom prst="rect">
              <a:avLst/>
            </a:prstGeom>
          </p:spPr>
        </p:pic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B90E8C26-0486-C4FA-6322-2C470A001477}"/>
                </a:ext>
              </a:extLst>
            </p:cNvPr>
            <p:cNvSpPr/>
            <p:nvPr/>
          </p:nvSpPr>
          <p:spPr>
            <a:xfrm>
              <a:off x="596210" y="2206194"/>
              <a:ext cx="2968440" cy="2121170"/>
            </a:xfrm>
            <a:prstGeom prst="ellipse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nnouncing a</a:t>
              </a:r>
              <a:r>
                <a:rPr lang="en-GB" sz="1600" b="1" kern="1200" dirty="0">
                  <a:latin typeface="Arial" panose="020B0604020202020204" pitchFamily="34" charset="0"/>
                  <a:cs typeface="Arial" panose="020B0604020202020204" pitchFamily="34" charset="0"/>
                </a:rPr>
                <a:t> new era for transplant recipients with CMV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565AE7F7-AD85-67F8-0708-F002F149D327}"/>
              </a:ext>
            </a:extLst>
          </p:cNvPr>
          <p:cNvSpPr txBox="1"/>
          <p:nvPr/>
        </p:nvSpPr>
        <p:spPr>
          <a:xfrm>
            <a:off x="4090751" y="1505886"/>
            <a:ext cx="33756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urrently available strategies are improving patient outcome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239EB18-D599-2A70-ABCF-CE259F967159}"/>
              </a:ext>
            </a:extLst>
          </p:cNvPr>
          <p:cNvSpPr txBox="1"/>
          <p:nvPr/>
        </p:nvSpPr>
        <p:spPr>
          <a:xfrm>
            <a:off x="8078940" y="1505886"/>
            <a:ext cx="40531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uture strategies will enhance the paradigm of CMV management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1AD41730-902B-9E44-EAC4-8A0171EB3B79}"/>
              </a:ext>
            </a:extLst>
          </p:cNvPr>
          <p:cNvGrpSpPr/>
          <p:nvPr/>
        </p:nvGrpSpPr>
        <p:grpSpPr>
          <a:xfrm>
            <a:off x="7965467" y="2939149"/>
            <a:ext cx="3986154" cy="1116000"/>
            <a:chOff x="7965467" y="2756269"/>
            <a:chExt cx="3986154" cy="1116000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39C694D8-1FA7-ADAE-F734-E6CEB697068E}"/>
                </a:ext>
              </a:extLst>
            </p:cNvPr>
            <p:cNvSpPr/>
            <p:nvPr/>
          </p:nvSpPr>
          <p:spPr>
            <a:xfrm>
              <a:off x="8149699" y="3001357"/>
              <a:ext cx="3801922" cy="684000"/>
            </a:xfrm>
            <a:prstGeom prst="rect">
              <a:avLst/>
            </a:prstGeom>
            <a:gradFill flip="none" rotWithShape="1">
              <a:gsLst>
                <a:gs pos="0">
                  <a:srgbClr val="524D79"/>
                </a:gs>
                <a:gs pos="100000">
                  <a:srgbClr val="6F699F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92000" tIns="0" rIns="0" bIns="0" rtlCol="0" anchor="ctr"/>
            <a:lstStyle/>
            <a:p>
              <a:r>
                <a:rPr lang="en-GB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gration of new therapies into current practice</a:t>
              </a:r>
              <a:endParaRPr lang="en-GB" sz="1600" kern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22F1768D-21FB-5190-E4D7-EAB00466FB8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65467" y="2756269"/>
              <a:ext cx="1116000" cy="1116000"/>
            </a:xfrm>
            <a:prstGeom prst="rect">
              <a:avLst/>
            </a:prstGeom>
          </p:spPr>
        </p:pic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B48EC40A-6B80-8FB3-3C7D-E58A85EEBAB7}"/>
              </a:ext>
            </a:extLst>
          </p:cNvPr>
          <p:cNvGrpSpPr/>
          <p:nvPr/>
        </p:nvGrpSpPr>
        <p:grpSpPr>
          <a:xfrm>
            <a:off x="4005694" y="2091428"/>
            <a:ext cx="3976017" cy="1116000"/>
            <a:chOff x="4005694" y="1908548"/>
            <a:chExt cx="3976017" cy="1116000"/>
          </a:xfrm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84FD688E-E88F-5829-006B-06CDB33A7606}"/>
                </a:ext>
              </a:extLst>
            </p:cNvPr>
            <p:cNvSpPr/>
            <p:nvPr/>
          </p:nvSpPr>
          <p:spPr>
            <a:xfrm>
              <a:off x="4180111" y="2148524"/>
              <a:ext cx="3801600" cy="684000"/>
            </a:xfrm>
            <a:prstGeom prst="rect">
              <a:avLst/>
            </a:prstGeom>
            <a:gradFill flip="none" rotWithShape="1">
              <a:gsLst>
                <a:gs pos="0">
                  <a:srgbClr val="6EB38F"/>
                </a:gs>
                <a:gs pos="100000">
                  <a:srgbClr val="4B8E6B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92000" tIns="0" rIns="0" bIns="0" rtlCol="0" anchor="ctr"/>
            <a:lstStyle/>
            <a:p>
              <a:r>
                <a:rPr lang="en-GB" sz="1600" kern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ognising the significant risks and major impact of CMV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E024FF65-BACE-5B47-DF26-0F4B6CB4D78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05694" y="1908548"/>
              <a:ext cx="1116000" cy="1116000"/>
            </a:xfrm>
            <a:prstGeom prst="rect">
              <a:avLst/>
            </a:prstGeom>
          </p:spPr>
        </p:pic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49F24AF-5D27-33C6-4BB3-D53C9D45E749}"/>
              </a:ext>
            </a:extLst>
          </p:cNvPr>
          <p:cNvGrpSpPr/>
          <p:nvPr/>
        </p:nvGrpSpPr>
        <p:grpSpPr>
          <a:xfrm>
            <a:off x="4005694" y="2946812"/>
            <a:ext cx="3976017" cy="1080000"/>
            <a:chOff x="4005694" y="2763932"/>
            <a:chExt cx="3976017" cy="1080000"/>
          </a:xfrm>
        </p:grpSpPr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E05224B0-A070-AEA7-3108-955F71016F58}"/>
                </a:ext>
              </a:extLst>
            </p:cNvPr>
            <p:cNvSpPr/>
            <p:nvPr/>
          </p:nvSpPr>
          <p:spPr>
            <a:xfrm>
              <a:off x="4180111" y="3001357"/>
              <a:ext cx="3801600" cy="684000"/>
            </a:xfrm>
            <a:prstGeom prst="rect">
              <a:avLst/>
            </a:prstGeom>
            <a:gradFill flip="none" rotWithShape="1">
              <a:gsLst>
                <a:gs pos="0">
                  <a:srgbClr val="6EB38F"/>
                </a:gs>
                <a:gs pos="100000">
                  <a:srgbClr val="4B8E6B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92000" tIns="0" rIns="0" bIns="0" rtlCol="0" anchor="ctr"/>
            <a:lstStyle/>
            <a:p>
              <a:r>
                <a:rPr lang="en-GB" sz="1600" kern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sessment of cell-mediated immunity</a:t>
              </a:r>
            </a:p>
          </p:txBody>
        </p: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2995BF8D-EA34-B8A0-4098-474B372E364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005694" y="2763932"/>
              <a:ext cx="1080000" cy="1080000"/>
            </a:xfrm>
            <a:prstGeom prst="rect">
              <a:avLst/>
            </a:prstGeom>
          </p:spPr>
        </p:pic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1ED6CF5D-E89A-92B1-EFF1-33CA38F0E0DE}"/>
              </a:ext>
            </a:extLst>
          </p:cNvPr>
          <p:cNvGrpSpPr/>
          <p:nvPr/>
        </p:nvGrpSpPr>
        <p:grpSpPr>
          <a:xfrm>
            <a:off x="7993252" y="2140118"/>
            <a:ext cx="3958369" cy="1080000"/>
            <a:chOff x="7993252" y="1957238"/>
            <a:chExt cx="3958369" cy="1080000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582BD67A-400F-1E89-E9C6-9299D95487E7}"/>
                </a:ext>
              </a:extLst>
            </p:cNvPr>
            <p:cNvSpPr/>
            <p:nvPr/>
          </p:nvSpPr>
          <p:spPr>
            <a:xfrm>
              <a:off x="8149699" y="2148524"/>
              <a:ext cx="3801922" cy="684000"/>
            </a:xfrm>
            <a:prstGeom prst="rect">
              <a:avLst/>
            </a:prstGeom>
            <a:gradFill flip="none" rotWithShape="1">
              <a:gsLst>
                <a:gs pos="0">
                  <a:srgbClr val="524D79"/>
                </a:gs>
                <a:gs pos="100000">
                  <a:srgbClr val="6F699F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92000" tIns="0" rIns="0" bIns="0" rtlCol="0" anchor="ctr"/>
            <a:lstStyle/>
            <a:p>
              <a:r>
                <a:rPr lang="en-GB" sz="1600" kern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hancing personalised and precision management</a:t>
              </a:r>
            </a:p>
          </p:txBody>
        </p: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321E5B4A-5902-E1AC-D961-02C16F41B59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993252" y="1957238"/>
              <a:ext cx="1080000" cy="1080000"/>
            </a:xfrm>
            <a:prstGeom prst="rect">
              <a:avLst/>
            </a:prstGeom>
          </p:spPr>
        </p:pic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5081994D-E926-27BE-A274-E1A34A4F66E3}"/>
              </a:ext>
            </a:extLst>
          </p:cNvPr>
          <p:cNvGrpSpPr/>
          <p:nvPr/>
        </p:nvGrpSpPr>
        <p:grpSpPr>
          <a:xfrm>
            <a:off x="8001467" y="3860324"/>
            <a:ext cx="3950154" cy="1044000"/>
            <a:chOff x="8001467" y="3677444"/>
            <a:chExt cx="3950154" cy="1044000"/>
          </a:xfrm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1D71DF0-7B5E-3CDD-64A4-7775AADEB846}"/>
                </a:ext>
              </a:extLst>
            </p:cNvPr>
            <p:cNvSpPr/>
            <p:nvPr/>
          </p:nvSpPr>
          <p:spPr>
            <a:xfrm>
              <a:off x="8149699" y="3854190"/>
              <a:ext cx="3801922" cy="684000"/>
            </a:xfrm>
            <a:prstGeom prst="rect">
              <a:avLst/>
            </a:prstGeom>
            <a:gradFill flip="none" rotWithShape="1">
              <a:gsLst>
                <a:gs pos="0">
                  <a:srgbClr val="524D79"/>
                </a:gs>
                <a:gs pos="100000">
                  <a:srgbClr val="6F699F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92000" tIns="0" rIns="0" bIns="0" rtlCol="0" anchor="ctr"/>
            <a:lstStyle/>
            <a:p>
              <a:r>
                <a:rPr lang="en-GB" sz="1600" kern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ccine development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1876261-AA34-CA5B-F9CE-BFEC9AAA10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flipH="1">
              <a:off x="8001467" y="3677444"/>
              <a:ext cx="1044000" cy="1044000"/>
            </a:xfrm>
            <a:prstGeom prst="rect">
              <a:avLst/>
            </a:prstGeom>
          </p:spPr>
        </p:pic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9BC59743-8E67-F99C-1E13-F7B842D27EA9}"/>
              </a:ext>
            </a:extLst>
          </p:cNvPr>
          <p:cNvGrpSpPr/>
          <p:nvPr/>
        </p:nvGrpSpPr>
        <p:grpSpPr>
          <a:xfrm>
            <a:off x="4023138" y="3851756"/>
            <a:ext cx="3958573" cy="1044000"/>
            <a:chOff x="4023138" y="3668876"/>
            <a:chExt cx="3958573" cy="1044000"/>
          </a:xfrm>
        </p:grpSpPr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786584E0-02E5-9D4E-1877-30109D3B3D67}"/>
                </a:ext>
              </a:extLst>
            </p:cNvPr>
            <p:cNvSpPr/>
            <p:nvPr/>
          </p:nvSpPr>
          <p:spPr>
            <a:xfrm>
              <a:off x="4180111" y="3854190"/>
              <a:ext cx="3801600" cy="684000"/>
            </a:xfrm>
            <a:prstGeom prst="rect">
              <a:avLst/>
            </a:prstGeom>
            <a:gradFill flip="none" rotWithShape="1">
              <a:gsLst>
                <a:gs pos="0">
                  <a:srgbClr val="6EB38F"/>
                </a:gs>
                <a:gs pos="100000">
                  <a:srgbClr val="4B8E6B"/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92000" tIns="0" rIns="0" bIns="0" rtlCol="0" anchor="ctr"/>
            <a:lstStyle/>
            <a:p>
              <a:r>
                <a:rPr lang="en-GB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ptimising use of prophylaxis and treatments</a:t>
              </a:r>
              <a:endParaRPr lang="en-GB" sz="1600" kern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EF961C1-A8A5-B481-2CBD-825F73B70BA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023138" y="3668876"/>
              <a:ext cx="1044000" cy="1044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6</TotalTime>
  <Words>98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Karthikeyan, Roopini -</cp:lastModifiedBy>
  <cp:revision>18</cp:revision>
  <dcterms:created xsi:type="dcterms:W3CDTF">2021-10-22T20:34:26Z</dcterms:created>
  <dcterms:modified xsi:type="dcterms:W3CDTF">2022-10-11T11:15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